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7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956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970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52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799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797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187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692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816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205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323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392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CDC0E-A15A-45DD-8AAB-1EECC5FAB100}" type="datetimeFigureOut">
              <a:rPr lang="en-US" smtClean="0"/>
              <a:t>4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1EEA0D-E94F-4B3A-BC86-863715172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290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2073" y="5164662"/>
            <a:ext cx="785706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</a:p>
          <a:p>
            <a:pPr algn="just">
              <a:lnSpc>
                <a:spcPct val="150000"/>
              </a:lnSpc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: Serum IgA (left panel) and gd-IgA1 (right panel) concentration in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atients with stable (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ray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dashed box) and progressive (white dashed box) disease after immunosuppression treatment. The progressive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hort shows higher median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d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IgA serum concentration.</a:t>
            </a:r>
          </a:p>
          <a:p>
            <a:pPr algn="just">
              <a:lnSpc>
                <a:spcPct val="150000"/>
              </a:lnSpc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: Correlation of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serum gd-IgA1 concentration in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atients (n=293). Negative correlation was calculated with Spearman rank correlation and the black line represents the correlation equation.</a:t>
            </a:r>
          </a:p>
          <a:p>
            <a:pPr algn="just">
              <a:lnSpc>
                <a:spcPct val="150000"/>
              </a:lnSpc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:  Serum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vs plasma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H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t the same sampling point in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A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atients (n=294) shows a small and insignificant correlation between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d plasma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H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ncentrat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8972" y="1681769"/>
            <a:ext cx="4336633" cy="16929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8971" y="-145988"/>
            <a:ext cx="3441600" cy="174759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12740" y="190812"/>
            <a:ext cx="3446400" cy="141079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31138" y="19081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31138" y="168176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1826" y="337466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8971" y="3391603"/>
            <a:ext cx="4592900" cy="179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0350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eed Elsevi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ed Elsevier</dc:creator>
  <cp:lastModifiedBy>Reed Elsevier</cp:lastModifiedBy>
  <cp:revision>1</cp:revision>
  <dcterms:created xsi:type="dcterms:W3CDTF">2017-04-25T15:04:57Z</dcterms:created>
  <dcterms:modified xsi:type="dcterms:W3CDTF">2017-04-25T15:05:20Z</dcterms:modified>
</cp:coreProperties>
</file>